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223" d="100"/>
          <a:sy n="223" d="100"/>
        </p:scale>
        <p:origin x="174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75E642A-058A-46FA-8C65-1593B97F86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6198" y="76912"/>
            <a:ext cx="4572000" cy="4572000"/>
          </a:xfrm>
          <a:prstGeom prst="rect">
            <a:avLst/>
          </a:prstGeom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A0271285-5B1B-4EE4-9BC4-4A34842A69CD}"/>
              </a:ext>
            </a:extLst>
          </p:cNvPr>
          <p:cNvGrpSpPr/>
          <p:nvPr/>
        </p:nvGrpSpPr>
        <p:grpSpPr>
          <a:xfrm>
            <a:off x="1927388" y="640828"/>
            <a:ext cx="2091655" cy="962857"/>
            <a:chOff x="271463" y="-571500"/>
            <a:chExt cx="2091655" cy="962857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8FCA583-78ED-48EB-8EA6-16E9FD19D3A2}"/>
                </a:ext>
              </a:extLst>
            </p:cNvPr>
            <p:cNvSpPr/>
            <p:nvPr/>
          </p:nvSpPr>
          <p:spPr>
            <a:xfrm>
              <a:off x="271463" y="-571499"/>
              <a:ext cx="2076450" cy="962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1874DA1B-1E5B-4920-8002-64A6A25437F6}"/>
                </a:ext>
              </a:extLst>
            </p:cNvPr>
            <p:cNvGrpSpPr/>
            <p:nvPr/>
          </p:nvGrpSpPr>
          <p:grpSpPr>
            <a:xfrm>
              <a:off x="317413" y="-571500"/>
              <a:ext cx="2045705" cy="962856"/>
              <a:chOff x="1867257" y="-462926"/>
              <a:chExt cx="2045705" cy="962856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5EEC866-2FA5-42AB-999C-3967E6B66380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2045705" cy="215444"/>
                <a:chOff x="1867257" y="-462926"/>
                <a:chExt cx="2045705" cy="215444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BB2E1573-CA68-4D2B-AB9F-7D923A55E166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C783FDA1-AAFC-42C6-AF80-D49407DE23A3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193033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Lymphocytes and small stromal</a:t>
                  </a:r>
                </a:p>
              </p:txBody>
            </p: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97537F1-0639-4EF7-BF91-A563D1137F6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575293" cy="215444"/>
                <a:chOff x="1867257" y="-339807"/>
                <a:chExt cx="575293" cy="215444"/>
              </a:xfrm>
            </p:grpSpPr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5F029507-AAC0-4ABB-9FEF-75305B683179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756EAFC-6EF2-4253-B0A6-26E731059D67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7835B5B0-94F7-4140-819F-286600660EC7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56502" cy="215444"/>
                <a:chOff x="1867257" y="-236663"/>
                <a:chExt cx="1256502" cy="215444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D2175DFB-4D1B-4641-A998-5CBF6AA973B5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221D3108-EDCD-4042-A3A1-94E3AC52AC6A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512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 with dark nuclei</a:t>
                  </a:r>
                </a:p>
              </p:txBody>
            </p: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8FAD3D3C-7A48-4AF8-B28D-E9A762852A2E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1491174" cy="215444"/>
                <a:chOff x="1867257" y="-103354"/>
                <a:chExt cx="1491174" cy="215444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798F2044-9FB5-4D52-9645-3FA8D55F999A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3D4C56F-5A1A-4B3B-90AA-C8FEE1DF615E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13580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and inflammatory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B72F15DE-42E9-40BC-BDEB-91ED6C0FED99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912812" cy="215444"/>
                <a:chOff x="1867257" y="22909"/>
                <a:chExt cx="912812" cy="215444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36EEC78B-F4F3-47A6-8DF0-5020CE98F2AF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66D7351-FA8B-4B95-AD50-55C6E214C85E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57631F7-DEF9-49E6-9767-6BCA38AEF39C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966760" cy="215444"/>
                <a:chOff x="1867257" y="148481"/>
                <a:chExt cx="966760" cy="215444"/>
              </a:xfrm>
            </p:grpSpPr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0F8B0F2B-7246-45DE-8983-A359FB189175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13AC7A7-98E7-4628-BB99-F3111C594B14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8451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indle-shape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54345780-EED8-4525-9CC1-A6C3757A9355}"/>
                  </a:ext>
                </a:extLst>
              </p:cNvPr>
              <p:cNvGrpSpPr/>
              <p:nvPr/>
            </p:nvGrpSpPr>
            <p:grpSpPr>
              <a:xfrm>
                <a:off x="1867257" y="284486"/>
                <a:ext cx="1155800" cy="215444"/>
                <a:chOff x="1867257" y="284486"/>
                <a:chExt cx="1155800" cy="215444"/>
              </a:xfrm>
            </p:grpSpPr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7F0923FE-B187-4655-9E0E-C19F1442DFB2}"/>
                    </a:ext>
                  </a:extLst>
                </p:cNvPr>
                <p:cNvSpPr/>
                <p:nvPr/>
              </p:nvSpPr>
              <p:spPr>
                <a:xfrm>
                  <a:off x="1867257" y="358955"/>
                  <a:ext cx="145278" cy="71157"/>
                </a:xfrm>
                <a:prstGeom prst="rect">
                  <a:avLst/>
                </a:prstGeom>
                <a:solidFill>
                  <a:srgbClr val="BCBD2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E611159-D7AE-403F-91B6-FEC9AC29B7BA}"/>
                    </a:ext>
                  </a:extLst>
                </p:cNvPr>
                <p:cNvSpPr txBox="1"/>
                <p:nvPr/>
              </p:nvSpPr>
              <p:spPr>
                <a:xfrm>
                  <a:off x="1974372" y="284486"/>
                  <a:ext cx="10486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 and stromal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8</TotalTime>
  <Words>19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8</cp:revision>
  <dcterms:created xsi:type="dcterms:W3CDTF">2022-09-09T23:27:10Z</dcterms:created>
  <dcterms:modified xsi:type="dcterms:W3CDTF">2024-02-03T02:22:14Z</dcterms:modified>
</cp:coreProperties>
</file>